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8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CA1C97-9D4D-4E3A-9BC8-4C68E4CF0A55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7C2F9F-5021-40FE-ABC1-1311457AB82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DBDC9B-5250-49CC-84E4-6AF52B3EDC08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E6C005-9B4D-4176-B118-7715BAB8599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E2CE84-093E-4563-B925-47EB04624ABA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A8529-A396-4760-848D-659ED889357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765B81-8D32-432A-B68B-82169DC3C1BB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E62C0B-AB26-41F7-AAC7-6727EAA3F7D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843F09-56E1-4AE1-865E-A0D3F1CDB702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2E65A-2F66-4BD0-A028-D828AAD667D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1F880A-6395-42FB-A1BC-4DA4AC96872A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2A190D-F63C-4715-A3E4-BF5541DC0D2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74ECC1-32FC-4499-BE59-F11D8D766525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EB364B-6D23-4877-B68B-571B5EE727C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13C1AB-1EC7-4DA5-A7CE-3A736E997E1D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DF9233-F911-4274-8B3A-0D6C6788A9E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CEC702-1735-4139-A31A-F299D4F0833F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E37D4E-62CC-479B-B8F1-6E911B526B8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2D4DD4-36E1-4DB1-9C27-FEAF73323871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5BDEEC-0E88-45E7-8BC7-65B864257D7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FEFC71-94A4-413F-9065-A9D5449A3A7E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BC0F2B-2A82-48C3-837C-ACF49FEA206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0D28134A-D54E-4AAA-BCF2-059F021B8F3B}" type="datetimeFigureOut">
              <a:rPr lang="de-DE"/>
              <a:pPr>
                <a:defRPr/>
              </a:pPr>
              <a:t>28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AE7C135-8014-4A3F-B311-4A252E289A7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7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95288" y="1196975"/>
            <a:ext cx="4140200" cy="4133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338" name="Textfeld 1"/>
          <p:cNvSpPr txBox="1">
            <a:spLocks noChangeArrowheads="1"/>
          </p:cNvSpPr>
          <p:nvPr/>
        </p:nvSpPr>
        <p:spPr bwMode="auto">
          <a:xfrm>
            <a:off x="28575" y="44450"/>
            <a:ext cx="8575675" cy="231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de-DE" sz="900">
                <a:latin typeface="Calibri" pitchFamily="34" charset="0"/>
              </a:rPr>
              <a:t>Supplementary Figure S2: Gene-expression of a AL359058 and LRRC61 transcripts in dependence on rs7806429 genotype</a:t>
            </a:r>
          </a:p>
        </p:txBody>
      </p:sp>
      <p:pic>
        <p:nvPicPr>
          <p:cNvPr id="14339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387850" y="1196975"/>
            <a:ext cx="4144963" cy="4137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Entwurfsvorlage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Calibri</vt:lpstr>
      <vt:lpstr>Arial</vt:lpstr>
      <vt:lpstr>Larissa</vt:lpstr>
      <vt:lpstr>Folie 1</vt:lpstr>
    </vt:vector>
  </TitlesOfParts>
  <Company>IT Verbund IMISE/ZK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kus Scholz</dc:creator>
  <cp:lastModifiedBy>in31kovacs</cp:lastModifiedBy>
  <cp:revision>6</cp:revision>
  <dcterms:created xsi:type="dcterms:W3CDTF">2014-08-21T17:23:35Z</dcterms:created>
  <dcterms:modified xsi:type="dcterms:W3CDTF">2014-08-28T09:50:18Z</dcterms:modified>
</cp:coreProperties>
</file>